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72" r:id="rId1"/>
  </p:sldMasterIdLst>
  <p:notesMasterIdLst>
    <p:notesMasterId r:id="rId3"/>
  </p:notesMasterIdLst>
  <p:sldIdLst>
    <p:sldId id="276" r:id="rId2"/>
  </p:sldIdLst>
  <p:sldSz cx="6858000" cy="9906000" type="A4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04" userDrawn="1">
          <p15:clr>
            <a:srgbClr val="A4A3A4"/>
          </p15:clr>
        </p15:guide>
        <p15:guide id="2" pos="363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FBBD9"/>
    <a:srgbClr val="D4D4D4"/>
    <a:srgbClr val="F4840C"/>
    <a:srgbClr val="F48003"/>
    <a:srgbClr val="49A9B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499" autoAdjust="0"/>
    <p:restoredTop sz="75991" autoAdjust="0"/>
  </p:normalViewPr>
  <p:slideViewPr>
    <p:cSldViewPr snapToGrid="0">
      <p:cViewPr varScale="1">
        <p:scale>
          <a:sx n="60" d="100"/>
          <a:sy n="60" d="100"/>
        </p:scale>
        <p:origin x="3768" y="184"/>
      </p:cViewPr>
      <p:guideLst>
        <p:guide orient="horz" pos="2304"/>
        <p:guide pos="363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fld id="{B3E0D2C5-265A-48B9-9B74-2F443EC82276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fld id="{B0BFBF00-5319-4174-90CC-EAC7A18AAF4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343530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BFBF00-5319-4174-90CC-EAC7A18AAF4F}" type="slidenum">
              <a:rPr lang="he-IL" smtClean="0"/>
              <a:t>1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582310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38047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283877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0602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52079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168870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63863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74718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85596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79155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35813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10084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11861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9" name="Object 3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5246843"/>
              </p:ext>
            </p:extLst>
          </p:nvPr>
        </p:nvGraphicFramePr>
        <p:xfrm>
          <a:off x="663587" y="1359886"/>
          <a:ext cx="1751616" cy="2068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405707" imgH="3230582" progId="Prism9.Document">
                  <p:embed/>
                </p:oleObj>
              </mc:Choice>
              <mc:Fallback>
                <p:oleObj name="Prism 9" r:id="rId3" imgW="2405707" imgH="323058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63587" y="1359886"/>
                        <a:ext cx="1751616" cy="2068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Object 3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2259334"/>
              </p:ext>
            </p:extLst>
          </p:nvPr>
        </p:nvGraphicFramePr>
        <p:xfrm>
          <a:off x="599209" y="3957637"/>
          <a:ext cx="1815994" cy="31265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2283981" imgH="4266025" progId="Prism9.Document">
                  <p:embed/>
                </p:oleObj>
              </mc:Choice>
              <mc:Fallback>
                <p:oleObj name="Prism 9" r:id="rId5" imgW="2283981" imgH="426602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99209" y="3957637"/>
                        <a:ext cx="1815994" cy="31265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3" name="TextBox 42">
            <a:extLst>
              <a:ext uri="{FF2B5EF4-FFF2-40B4-BE49-F238E27FC236}">
                <a16:creationId xmlns:a16="http://schemas.microsoft.com/office/drawing/2014/main" id="{9A9108AD-8941-DE4D-9976-E095035FA618}"/>
              </a:ext>
            </a:extLst>
          </p:cNvPr>
          <p:cNvSpPr txBox="1"/>
          <p:nvPr/>
        </p:nvSpPr>
        <p:spPr>
          <a:xfrm>
            <a:off x="117386" y="26108"/>
            <a:ext cx="6513238" cy="46166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6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duced translation initiation increases antibiotic-mediated readthrough– the effect on active </a:t>
            </a:r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catenin</a:t>
            </a:r>
            <a:endParaRPr lang="he-I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4248448" y="1479225"/>
            <a:ext cx="1625600" cy="1992313"/>
            <a:chOff x="4385589" y="1429274"/>
            <a:chExt cx="1625600" cy="1992313"/>
          </a:xfrm>
        </p:grpSpPr>
        <p:graphicFrame>
          <p:nvGraphicFramePr>
            <p:cNvPr id="44" name="Object 4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48218955"/>
                </p:ext>
              </p:extLst>
            </p:nvPr>
          </p:nvGraphicFramePr>
          <p:xfrm>
            <a:off x="4385589" y="1429274"/>
            <a:ext cx="1625600" cy="19923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7" imgW="2542918" imgH="2599592" progId="Prism9.Document">
                    <p:embed/>
                  </p:oleObj>
                </mc:Choice>
                <mc:Fallback>
                  <p:oleObj name="Prism 9" r:id="rId7" imgW="2542918" imgH="2599592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385589" y="1429274"/>
                          <a:ext cx="1625600" cy="19923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47" name="Straight Connector 46"/>
            <p:cNvCxnSpPr/>
            <p:nvPr/>
          </p:nvCxnSpPr>
          <p:spPr>
            <a:xfrm>
              <a:off x="4993952" y="1666863"/>
              <a:ext cx="70068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/>
            <p:cNvSpPr txBox="1"/>
            <p:nvPr/>
          </p:nvSpPr>
          <p:spPr>
            <a:xfrm>
              <a:off x="5198389" y="1460712"/>
              <a:ext cx="344966" cy="2308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pPr marL="0" marR="0" lvl="0" indent="0" algn="r" defTabSz="914400" rtl="1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NS</a:t>
              </a:r>
              <a:endParaRPr kumimoji="0" lang="he-IL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49" name="Object 4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09157027"/>
              </p:ext>
            </p:extLst>
          </p:nvPr>
        </p:nvGraphicFramePr>
        <p:xfrm>
          <a:off x="4229489" y="4808011"/>
          <a:ext cx="1789479" cy="21110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2542918" imgH="2617960" progId="Prism9.Document">
                  <p:embed/>
                </p:oleObj>
              </mc:Choice>
              <mc:Fallback>
                <p:oleObj name="Prism 9" r:id="rId9" imgW="2542918" imgH="261796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229489" y="4808011"/>
                        <a:ext cx="1789479" cy="21110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2" name="TextBox 51"/>
          <p:cNvSpPr txBox="1"/>
          <p:nvPr/>
        </p:nvSpPr>
        <p:spPr>
          <a:xfrm>
            <a:off x="2946121" y="781646"/>
            <a:ext cx="810197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>
            <a:defPPr>
              <a:defRPr lang="he-IL"/>
            </a:defPPr>
            <a:lvl1pPr>
              <a:defRPr sz="1050"/>
            </a:lvl1pPr>
          </a:lstStyle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lo320</a:t>
            </a:r>
            <a:endParaRPr kumimoji="0" lang="he-IL" sz="1200" b="0" i="0" u="sng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2946121" y="4329100"/>
            <a:ext cx="810197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>
            <a:defPPr>
              <a:defRPr lang="he-IL"/>
            </a:defPPr>
            <a:lvl1pPr>
              <a:defRPr sz="1050"/>
            </a:lvl1pPr>
          </a:lstStyle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W403</a:t>
            </a:r>
            <a:endParaRPr kumimoji="0" lang="he-IL" sz="1200" b="0" i="0" u="sng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214712" y="1172109"/>
            <a:ext cx="320922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  <a:endParaRPr kumimoji="0" lang="he-IL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214712" y="4131493"/>
            <a:ext cx="320922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  <a:endParaRPr kumimoji="0" lang="he-IL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6" name="TextBox 99">
            <a:extLst>
              <a:ext uri="{FF2B5EF4-FFF2-40B4-BE49-F238E27FC236}">
                <a16:creationId xmlns:a16="http://schemas.microsoft.com/office/drawing/2014/main" id="{053EB08B-B2A3-4629-862F-B449B78DF74B}"/>
              </a:ext>
            </a:extLst>
          </p:cNvPr>
          <p:cNvSpPr txBox="1"/>
          <p:nvPr/>
        </p:nvSpPr>
        <p:spPr>
          <a:xfrm>
            <a:off x="4063418" y="1172109"/>
            <a:ext cx="332142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</a:t>
            </a:r>
            <a:endParaRPr kumimoji="0" lang="he-IL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4063418" y="4131493"/>
            <a:ext cx="332142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marL="0" marR="0" lvl="0" indent="0" algn="r" defTabSz="914400" rtl="1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</a:t>
            </a:r>
            <a:endParaRPr kumimoji="0" lang="he-IL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89364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72</TotalTime>
  <Words>23</Words>
  <Application>Microsoft Macintosh PowerPoint</Application>
  <PresentationFormat>A4 Paper (210x297 mm)</PresentationFormat>
  <Paragraphs>9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Times New Roman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Rina Arbesfeld</cp:lastModifiedBy>
  <cp:revision>402</cp:revision>
  <dcterms:created xsi:type="dcterms:W3CDTF">2021-05-06T04:50:58Z</dcterms:created>
  <dcterms:modified xsi:type="dcterms:W3CDTF">2023-11-10T08:54:52Z</dcterms:modified>
</cp:coreProperties>
</file>